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9" r:id="rId4"/>
    <p:sldId id="260" r:id="rId5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0" d="100"/>
          <a:sy n="80" d="100"/>
        </p:scale>
        <p:origin x="754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E2424D7-FAC8-556B-C8A0-5527F8311FF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F6D47B40-7452-1841-B5F4-2404DC1387E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F82F243-8CA3-12F5-29E6-49D16C923A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BCC7E-5EDE-4D8C-95ED-E924436D67F7}" type="datetimeFigureOut">
              <a:rPr lang="ko-KR" altLang="en-US" smtClean="0"/>
              <a:t>2023-07-1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0801535-C253-BA88-DCDC-9C789DDD89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28E4C7E-278E-52FE-6356-B965DD52B0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FE1B7-1AE5-4D55-8F43-4A7FB45C009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175732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FA8937F-FFF8-2006-852C-8537C5D585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ED327AE2-4190-ADAD-0ED9-9A18082D12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73336D1-5283-CD7F-281C-9E8847FEB6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BCC7E-5EDE-4D8C-95ED-E924436D67F7}" type="datetimeFigureOut">
              <a:rPr lang="ko-KR" altLang="en-US" smtClean="0"/>
              <a:t>2023-07-1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89335E4-7157-7590-F871-42660CF4C2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5ADB4D0-4CB0-897F-2AE3-ED16E3B8E7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FE1B7-1AE5-4D55-8F43-4A7FB45C009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872622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BAF31972-16B2-4E7A-B713-1E3BC49D634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468E855D-4A19-21D7-02F2-F98B937C2C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E5888E6-8075-8305-8640-1260893B2C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BCC7E-5EDE-4D8C-95ED-E924436D67F7}" type="datetimeFigureOut">
              <a:rPr lang="ko-KR" altLang="en-US" smtClean="0"/>
              <a:t>2023-07-1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77B7CD9-4520-00C9-B505-C5B01EEB6C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5BB4FC6-55DD-B911-66F7-7A5EBAB19E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FE1B7-1AE5-4D55-8F43-4A7FB45C009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31006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D7ABCA9-C442-617C-8E9E-5FE47C47DC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BD7EFD7B-7009-1740-1678-70861D7F833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0EE4299-B164-B209-CB43-91864EE243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BCC7E-5EDE-4D8C-95ED-E924436D67F7}" type="datetimeFigureOut">
              <a:rPr lang="ko-KR" altLang="en-US" smtClean="0"/>
              <a:t>2023-07-1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588AFE5-11A3-820C-3EC3-6FD7219991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942D6F6-9845-0488-40BC-1FD29C1F5E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FE1B7-1AE5-4D55-8F43-4A7FB45C009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613423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3036B95-C493-5E8C-F75F-E9B737F9BB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A7861048-AB53-79D7-5D62-44DACA5AA5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8893CE4-AB35-40EF-F513-ED99F6918B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BCC7E-5EDE-4D8C-95ED-E924436D67F7}" type="datetimeFigureOut">
              <a:rPr lang="ko-KR" altLang="en-US" smtClean="0"/>
              <a:t>2023-07-1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ABF8CE7-C899-5A8D-B022-FE4164487A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D6D8330-E4B8-2072-08B0-850C56C086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FE1B7-1AE5-4D55-8F43-4A7FB45C009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761791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451010C-BE5B-A0A7-3B48-43E357886A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3088D1B0-16F9-6C2D-FE49-2BBD1B7957F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E3A90815-030C-D739-EF27-569083AB12A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97844C8A-8394-288E-7D10-6623A93E8B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BCC7E-5EDE-4D8C-95ED-E924436D67F7}" type="datetimeFigureOut">
              <a:rPr lang="ko-KR" altLang="en-US" smtClean="0"/>
              <a:t>2023-07-14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2F5CC535-F544-0DA8-3F38-ED457B0FEF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24EFC3D9-41D4-02B9-3610-43DB1FDE59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FE1B7-1AE5-4D55-8F43-4A7FB45C009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134808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4F416ED-B2C3-CA7E-6A75-B7F2C4B82C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3B29C247-2991-6B2E-015A-97EB10D84C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533F0ADC-6FE7-83E0-A4A4-007FFEEA1F8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44F01ACE-180A-24BF-1F1C-FEE32710E29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60143D72-9878-2520-57BD-3A2D5EA8723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5A17B95B-72EC-36F5-7619-B8CEA9785A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BCC7E-5EDE-4D8C-95ED-E924436D67F7}" type="datetimeFigureOut">
              <a:rPr lang="ko-KR" altLang="en-US" smtClean="0"/>
              <a:t>2023-07-14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D11E36FF-10B1-137B-F1B3-7D62593479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746B1378-CA17-BC40-13E9-531A82A07C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FE1B7-1AE5-4D55-8F43-4A7FB45C009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677878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66C883D-44D5-DCF0-4654-2C9E527753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AED5CAFF-25A6-6FF7-F7A9-DFAEA941FD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BCC7E-5EDE-4D8C-95ED-E924436D67F7}" type="datetimeFigureOut">
              <a:rPr lang="ko-KR" altLang="en-US" smtClean="0"/>
              <a:t>2023-07-14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29571DC3-2FAA-F9AA-CCBF-1C22126489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887FFAD3-04CE-7C78-74E3-A252C73B47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FE1B7-1AE5-4D55-8F43-4A7FB45C009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504479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7AA35717-CDE9-8415-6DB0-D312C0BCBF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BCC7E-5EDE-4D8C-95ED-E924436D67F7}" type="datetimeFigureOut">
              <a:rPr lang="ko-KR" altLang="en-US" smtClean="0"/>
              <a:t>2023-07-14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C6A3C46C-9126-4129-3DC0-48BBBFC55F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DAFCE151-86E6-7CF1-E979-067CE8A02B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FE1B7-1AE5-4D55-8F43-4A7FB45C009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12106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4799DF1-1236-A25A-AB17-8E9043936C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167764DB-F55E-D60B-B792-F100340644C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ECD28D9B-A030-5F18-73DE-6CFF6FE3BA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03ACE219-2A45-82AE-0DA4-96E734958A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BCC7E-5EDE-4D8C-95ED-E924436D67F7}" type="datetimeFigureOut">
              <a:rPr lang="ko-KR" altLang="en-US" smtClean="0"/>
              <a:t>2023-07-14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1A7B5C3-E13C-B578-B95A-5A0FD78850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46C9BD98-866C-BC5C-EE76-FA8024A6E0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FE1B7-1AE5-4D55-8F43-4A7FB45C009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767760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521AD1B-D543-27A5-B829-1819D7715A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087FEAA2-A1B8-62F6-3EBA-9145AC8AABD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0B360E69-8BFC-BAD7-DAB4-9CC0D85D7EF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952B45E-1D96-72E3-D85E-53FC605A8A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BCC7E-5EDE-4D8C-95ED-E924436D67F7}" type="datetimeFigureOut">
              <a:rPr lang="ko-KR" altLang="en-US" smtClean="0"/>
              <a:t>2023-07-14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07FF4FE2-1EE6-6EA0-BD6D-CEEDD49C82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CA6F0849-4077-EBA1-2D2F-716E510604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FE1B7-1AE5-4D55-8F43-4A7FB45C009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042724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33AFBD98-BE87-8D9B-6F57-5C1809E022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E0E1C35-756C-72A6-90B3-30CD073CDB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FB86C34-A5D3-05B9-F7DF-72C2F0A1FC7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ABCC7E-5EDE-4D8C-95ED-E924436D67F7}" type="datetimeFigureOut">
              <a:rPr lang="ko-KR" altLang="en-US" smtClean="0"/>
              <a:t>2023-07-1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E5FDB9F-AE26-51FD-6375-AD8C3051189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B17DCF4-C8DD-C476-3E6E-BE2E186F115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7FE1B7-1AE5-4D55-8F43-4A7FB45C009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558267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>
            <a:extLst>
              <a:ext uri="{FF2B5EF4-FFF2-40B4-BE49-F238E27FC236}">
                <a16:creationId xmlns:a16="http://schemas.microsoft.com/office/drawing/2014/main" id="{3462192E-16BE-542C-9DD4-903A5F3B49C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471399"/>
            <a:ext cx="12192000" cy="591520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38C32BE-9BF6-249E-6541-19F0459256BF}"/>
              </a:ext>
            </a:extLst>
          </p:cNvPr>
          <p:cNvSpPr txBox="1"/>
          <p:nvPr/>
        </p:nvSpPr>
        <p:spPr>
          <a:xfrm>
            <a:off x="228600" y="76200"/>
            <a:ext cx="29033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A. Objective response rate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14613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>
            <a:extLst>
              <a:ext uri="{FF2B5EF4-FFF2-40B4-BE49-F238E27FC236}">
                <a16:creationId xmlns:a16="http://schemas.microsoft.com/office/drawing/2014/main" id="{DAD11238-1C24-E067-3B95-B65455C21B8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471399"/>
            <a:ext cx="12192000" cy="591520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246D6CB6-F8CA-6386-F978-BFFD7D5B4DC5}"/>
              </a:ext>
            </a:extLst>
          </p:cNvPr>
          <p:cNvSpPr txBox="1"/>
          <p:nvPr/>
        </p:nvSpPr>
        <p:spPr>
          <a:xfrm>
            <a:off x="228600" y="76200"/>
            <a:ext cx="2518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. Disease control rate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512459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5587BC7-6A23-B84B-E2CD-544DC19A88B6}"/>
              </a:ext>
            </a:extLst>
          </p:cNvPr>
          <p:cNvSpPr txBox="1"/>
          <p:nvPr/>
        </p:nvSpPr>
        <p:spPr>
          <a:xfrm>
            <a:off x="228600" y="76200"/>
            <a:ext cx="30315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C. Progression-free survival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BDCD3C99-028C-C65A-3B53-8A8B4B50E85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471399"/>
            <a:ext cx="12192000" cy="59152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560720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>
            <a:extLst>
              <a:ext uri="{FF2B5EF4-FFF2-40B4-BE49-F238E27FC236}">
                <a16:creationId xmlns:a16="http://schemas.microsoft.com/office/drawing/2014/main" id="{2914A834-8E0E-E45E-658C-DA4A2E35BD5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471399"/>
            <a:ext cx="12192000" cy="591520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05D0BF23-1A8D-7FD6-4690-1171F3B24816}"/>
              </a:ext>
            </a:extLst>
          </p:cNvPr>
          <p:cNvSpPr txBox="1"/>
          <p:nvPr/>
        </p:nvSpPr>
        <p:spPr>
          <a:xfrm>
            <a:off x="228600" y="76200"/>
            <a:ext cx="20569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D. Overall survival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405349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7</TotalTime>
  <Words>18</Words>
  <Application>Microsoft Office PowerPoint</Application>
  <PresentationFormat>와이드스크린</PresentationFormat>
  <Paragraphs>4</Paragraphs>
  <Slides>4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7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Yoon Seung Bae</dc:creator>
  <cp:lastModifiedBy>Yoon Seung Bae</cp:lastModifiedBy>
  <cp:revision>1</cp:revision>
  <dcterms:created xsi:type="dcterms:W3CDTF">2023-07-14T18:03:14Z</dcterms:created>
  <dcterms:modified xsi:type="dcterms:W3CDTF">2023-07-14T22:41:12Z</dcterms:modified>
</cp:coreProperties>
</file>